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288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ru-RU" smtClean="0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42003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65820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39016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18258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60879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80654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02358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1770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8532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04925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ru-RU" smtClean="0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10343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BCFA9F-7C47-49F5-A01D-AC0392EB3841}" type="datetimeFigureOut">
              <a:rPr lang="ru-RU" smtClean="0"/>
              <a:t>03.08.2020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AD17EC-7DB6-4898-8E91-D82839213CC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7063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omgenomics.com/circa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16" y="0"/>
            <a:ext cx="6779340" cy="638306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81000" y="6716486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ru-RU" dirty="0"/>
          </a:p>
        </p:txBody>
      </p:sp>
      <p:sp>
        <p:nvSpPr>
          <p:cNvPr id="6" name="Прямоугольник 5"/>
          <p:cNvSpPr/>
          <p:nvPr/>
        </p:nvSpPr>
        <p:spPr>
          <a:xfrm>
            <a:off x="202614" y="6512510"/>
            <a:ext cx="6444343" cy="26314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 circular genome diagram of M.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vi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CG 1 (Russia) vaccine seeds and clinical isolates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o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was created with Circa (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http://omgenomics.com/circ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ru-RU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cks from inside: scale i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gabase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G.C. content histogram (yellow fill with black stroke) calculated from the ratio (G+C)/(A+T+G+C) using a 1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lobas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kb) non-overlapping sliding window; G.C. bias plots calculated from the ratio (G C)/(G+C) using a 1 kb non-overlapping window (blue plot) and a 10 kb non-overlapping window (translucent black plot); strain number labeled tracks (alternating grey and white) each depicting strain-specific insertions/deletions (blue/red transverse marks) and SNPs (dots*) identified relative to the reference genome of M.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vi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CG-1 (Russia)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ession number CP013741); tracks depicting ORFs (blue transverse marks) alongside affected CDSs (black, orange and red transverse marks†) on forward and reverse strands; names of affected genes colored according to an impact type of the most severe variant affecting a particular gene. Notes. *Sizes and colors determine a particular SNP type: small black – synonymous SNP, large orange – missense SNP; †color determines an impact type of a particular variant on a particular CDS assigned according to the following concept: low impact (black mark) – synonymous SNPs, moderate impact (orange mark) – missense SNPs and conservative insertions/deletions, high impact (red mark) – nonsense SNPs and frameshift insertions/deletions.</a:t>
            </a:r>
            <a:endParaRPr lang="ru-RU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43580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78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gor Mokrousov</dc:creator>
  <cp:lastModifiedBy>Igor Mokrousov</cp:lastModifiedBy>
  <cp:revision>2</cp:revision>
  <dcterms:created xsi:type="dcterms:W3CDTF">2020-08-03T14:12:49Z</dcterms:created>
  <dcterms:modified xsi:type="dcterms:W3CDTF">2020-08-03T14:34:21Z</dcterms:modified>
</cp:coreProperties>
</file>